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5921" autoAdjust="0"/>
  </p:normalViewPr>
  <p:slideViewPr>
    <p:cSldViewPr snapToGrid="0">
      <p:cViewPr varScale="1">
        <p:scale>
          <a:sx n="110" d="100"/>
          <a:sy n="110" d="100"/>
        </p:scale>
        <p:origin x="1644" y="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E8C9-F4BD-45AD-B01D-AB43156269F6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DE25-B010-4F35-B57E-1F7E8B086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92930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E8C9-F4BD-45AD-B01D-AB43156269F6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DE25-B010-4F35-B57E-1F7E8B086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81438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E8C9-F4BD-45AD-B01D-AB43156269F6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DE25-B010-4F35-B57E-1F7E8B086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8791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E8C9-F4BD-45AD-B01D-AB43156269F6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DE25-B010-4F35-B57E-1F7E8B086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6704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E8C9-F4BD-45AD-B01D-AB43156269F6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DE25-B010-4F35-B57E-1F7E8B086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4967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E8C9-F4BD-45AD-B01D-AB43156269F6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DE25-B010-4F35-B57E-1F7E8B086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0045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E8C9-F4BD-45AD-B01D-AB43156269F6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DE25-B010-4F35-B57E-1F7E8B086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60241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E8C9-F4BD-45AD-B01D-AB43156269F6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DE25-B010-4F35-B57E-1F7E8B086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440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E8C9-F4BD-45AD-B01D-AB43156269F6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DE25-B010-4F35-B57E-1F7E8B086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420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E8C9-F4BD-45AD-B01D-AB43156269F6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DE25-B010-4F35-B57E-1F7E8B086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4279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E6E8C9-F4BD-45AD-B01D-AB43156269F6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5DE25-B010-4F35-B57E-1F7E8B086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6686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E6E8C9-F4BD-45AD-B01D-AB43156269F6}" type="datetimeFigureOut">
              <a:rPr lang="en-US" smtClean="0"/>
              <a:t>8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E5DE25-B010-4F35-B57E-1F7E8B0863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3056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9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9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B801F2E3-F055-4747-82A8-0E68EA88F6E0}"/>
              </a:ext>
            </a:extLst>
          </p:cNvPr>
          <p:cNvSpPr/>
          <p:nvPr/>
        </p:nvSpPr>
        <p:spPr>
          <a:xfrm>
            <a:off x="858129" y="2182505"/>
            <a:ext cx="7104185" cy="206210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Bef>
                <a:spcPts val="1200"/>
              </a:spcBef>
              <a:spcAft>
                <a:spcPts val="600"/>
              </a:spcAft>
            </a:pPr>
            <a:r>
              <a:rPr lang="en-US" sz="1600" b="1" i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ry Material</a:t>
            </a:r>
          </a:p>
          <a:p>
            <a:pPr algn="ctr">
              <a:spcBef>
                <a:spcPts val="1200"/>
              </a:spcBef>
              <a:spcAft>
                <a:spcPts val="1800"/>
              </a:spcAft>
            </a:pPr>
            <a:r>
              <a:rPr lang="en-US" sz="1600" b="1" dirty="0">
                <a:latin typeface="Times New Roman" panose="02020603050405020304" pitchFamily="18" charset="0"/>
                <a:ea typeface="Calibri" panose="020F0502020204030204" pitchFamily="34" charset="0"/>
              </a:rPr>
              <a:t>Microbiomes associated with foods from plant and animal sources</a:t>
            </a:r>
          </a:p>
          <a:p>
            <a:pPr>
              <a:spcBef>
                <a:spcPts val="1200"/>
              </a:spcBef>
              <a:spcAft>
                <a:spcPts val="12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Karen G. Jarvis</a:t>
            </a:r>
            <a:r>
              <a:rPr lang="en-US" sz="1200" b="1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*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, Christopher J. Grim, Ninalynn Daquigan, Paul M. Morin, Laura M. Howard, Julia E. Manetas, Andrea Ottesen, Padmini Ramachandran, James R. White</a:t>
            </a:r>
          </a:p>
          <a:p>
            <a:pPr>
              <a:spcBef>
                <a:spcPts val="1200"/>
              </a:spcBef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Correspondence: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aren Jarvis: karen.jarvis@fda.hhs.gov</a:t>
            </a:r>
            <a:endParaRPr lang="en-US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 descr="C:\Users\Elaine.Scott\Documents\LaTex\____TEST____Frontiers_LaTeX_Templates_V2.5\Frontiers LaTeX (Science, Health and Engineering) V2.5 - with Supplementary material (V1.2)\logo1.jpg">
            <a:extLst>
              <a:ext uri="{FF2B5EF4-FFF2-40B4-BE49-F238E27FC236}">
                <a16:creationId xmlns:a16="http://schemas.microsoft.com/office/drawing/2014/main" id="{3635C478-4F3B-4B14-904E-A4C210F91C03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6082" y="479718"/>
            <a:ext cx="1382395" cy="49657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10698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28600" y="381000"/>
            <a:ext cx="51171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:  Box plot of </a:t>
            </a:r>
            <a:r>
              <a:rPr lang="en-US" sz="1200" i="1" dirty="0"/>
              <a:t>Enterobacteriacea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bundances 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942"/>
          <a:stretch/>
        </p:blipFill>
        <p:spPr>
          <a:xfrm>
            <a:off x="259504" y="852548"/>
            <a:ext cx="4085287" cy="429768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642"/>
          <a:stretch/>
        </p:blipFill>
        <p:spPr>
          <a:xfrm>
            <a:off x="4566950" y="867363"/>
            <a:ext cx="4098193" cy="429768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4B421E7-1252-4AAE-8713-B48459FC8B21}"/>
              </a:ext>
            </a:extLst>
          </p:cNvPr>
          <p:cNvSpPr txBox="1"/>
          <p:nvPr/>
        </p:nvSpPr>
        <p:spPr>
          <a:xfrm>
            <a:off x="328246" y="5606562"/>
            <a:ext cx="79013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:  Box plot of </a:t>
            </a:r>
            <a:r>
              <a:rPr lang="en-US" sz="1200" i="1" dirty="0"/>
              <a:t>Enterobacteriacea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bundances in cilantro, cucumbers, masala spice mixes, smoked salmon, mung bean sprout A, and mung bean sprout B. Left panel shows a break out of 8 cilantro sample groups, and mung bean sprout A and B. Right panel shows all samples of each food as one group.</a:t>
            </a:r>
          </a:p>
        </p:txBody>
      </p:sp>
      <p:sp>
        <p:nvSpPr>
          <p:cNvPr id="2" name="TextBox 1"/>
          <p:cNvSpPr txBox="1"/>
          <p:nvPr/>
        </p:nvSpPr>
        <p:spPr>
          <a:xfrm rot="16200000">
            <a:off x="-723107" y="2523412"/>
            <a:ext cx="208303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Proportional abundance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3582280" y="2607161"/>
            <a:ext cx="208303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Proportional abundance</a:t>
            </a:r>
          </a:p>
        </p:txBody>
      </p:sp>
    </p:spTree>
    <p:extLst>
      <p:ext uri="{BB962C8B-B14F-4D97-AF65-F5344CB8AC3E}">
        <p14:creationId xmlns:p14="http://schemas.microsoft.com/office/powerpoint/2010/main" val="11197366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427" y="1378041"/>
            <a:ext cx="4480560" cy="448056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33520" y="1378041"/>
            <a:ext cx="4480560" cy="448056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B1F4515-14D1-4191-B5AD-F5FD08F89214}"/>
              </a:ext>
            </a:extLst>
          </p:cNvPr>
          <p:cNvSpPr txBox="1"/>
          <p:nvPr/>
        </p:nvSpPr>
        <p:spPr>
          <a:xfrm>
            <a:off x="328246" y="556550"/>
            <a:ext cx="55465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:  Box plot of </a:t>
            </a:r>
            <a:r>
              <a:rPr lang="en-US" sz="1200" i="1" dirty="0"/>
              <a:t>Oxalobacteracea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bundances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2AF7AF6-DB6E-4F63-AEA3-F83070358EB8}"/>
              </a:ext>
            </a:extLst>
          </p:cNvPr>
          <p:cNvSpPr txBox="1"/>
          <p:nvPr/>
        </p:nvSpPr>
        <p:spPr>
          <a:xfrm>
            <a:off x="380620" y="5903587"/>
            <a:ext cx="79013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2:  Box plot of </a:t>
            </a:r>
            <a:r>
              <a:rPr lang="en-US" sz="1200" i="1" dirty="0"/>
              <a:t>Oxalobacteracea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bundances in cilantro, cucumbers, masala spice mixes, smoked salmon, mung bean sprout A, and mung bean sprout B. Left panel shows a break out of 8 cilantro sample groups, and mung bean sprout A and B. Right panel shows all samples of each food as one group.</a:t>
            </a:r>
          </a:p>
        </p:txBody>
      </p:sp>
      <p:sp>
        <p:nvSpPr>
          <p:cNvPr id="6" name="TextBox 5"/>
          <p:cNvSpPr txBox="1"/>
          <p:nvPr/>
        </p:nvSpPr>
        <p:spPr>
          <a:xfrm rot="16200000">
            <a:off x="-853511" y="2973302"/>
            <a:ext cx="208303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Proportional abundance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3566282" y="3102819"/>
            <a:ext cx="208303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Proportional abundance</a:t>
            </a:r>
          </a:p>
        </p:txBody>
      </p:sp>
    </p:spTree>
    <p:extLst>
      <p:ext uri="{BB962C8B-B14F-4D97-AF65-F5344CB8AC3E}">
        <p14:creationId xmlns:p14="http://schemas.microsoft.com/office/powerpoint/2010/main" val="25391497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384" y="1008358"/>
            <a:ext cx="4480560" cy="448056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1529" y="1008358"/>
            <a:ext cx="4480560" cy="448056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FE65225-F9B8-4D53-8D2D-A4944F66B8FE}"/>
              </a:ext>
            </a:extLst>
          </p:cNvPr>
          <p:cNvSpPr txBox="1"/>
          <p:nvPr/>
        </p:nvSpPr>
        <p:spPr>
          <a:xfrm>
            <a:off x="328246" y="556550"/>
            <a:ext cx="62396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:  Box plot of </a:t>
            </a:r>
            <a:r>
              <a:rPr lang="en-US" sz="1200" i="1" dirty="0"/>
              <a:t>Flavobacterium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undances 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9E9B22F-4A08-48B6-8491-F5D057D417B3}"/>
              </a:ext>
            </a:extLst>
          </p:cNvPr>
          <p:cNvSpPr txBox="1"/>
          <p:nvPr/>
        </p:nvSpPr>
        <p:spPr>
          <a:xfrm>
            <a:off x="380620" y="5903587"/>
            <a:ext cx="790135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3:  Box plot of </a:t>
            </a:r>
            <a:r>
              <a:rPr lang="en-US" sz="1200" i="1" dirty="0"/>
              <a:t>Flavobacteri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bundances in cilantro, cucumbers, masala spice mixes, smoked salmon, mung bean sprout A, and mung bean sprout B. Left panel shows a break out of 8 cilantro sample groups, and mung bean sprout A and B. Right panel shows all samples of each food as one group.</a:t>
            </a:r>
          </a:p>
        </p:txBody>
      </p:sp>
      <p:sp>
        <p:nvSpPr>
          <p:cNvPr id="6" name="TextBox 5"/>
          <p:cNvSpPr txBox="1"/>
          <p:nvPr/>
        </p:nvSpPr>
        <p:spPr>
          <a:xfrm rot="16200000">
            <a:off x="-864950" y="2587933"/>
            <a:ext cx="208303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Proportional abundance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3509079" y="2648798"/>
            <a:ext cx="208303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Proportional abundance</a:t>
            </a:r>
          </a:p>
        </p:txBody>
      </p:sp>
    </p:spTree>
    <p:extLst>
      <p:ext uri="{BB962C8B-B14F-4D97-AF65-F5344CB8AC3E}">
        <p14:creationId xmlns:p14="http://schemas.microsoft.com/office/powerpoint/2010/main" val="38423795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245" y="934351"/>
            <a:ext cx="4480560" cy="448056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3440" y="934351"/>
            <a:ext cx="4480560" cy="4480560"/>
          </a:xfrm>
          <a:prstGeom prst="rect">
            <a:avLst/>
          </a:prstGeom>
        </p:spPr>
      </p:pic>
      <p:sp>
        <p:nvSpPr>
          <p:cNvPr id="5" name="Oval 4"/>
          <p:cNvSpPr/>
          <p:nvPr/>
        </p:nvSpPr>
        <p:spPr>
          <a:xfrm>
            <a:off x="2461591" y="3495668"/>
            <a:ext cx="281609" cy="30215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Oval 5"/>
          <p:cNvSpPr/>
          <p:nvPr/>
        </p:nvSpPr>
        <p:spPr>
          <a:xfrm>
            <a:off x="6437245" y="3539247"/>
            <a:ext cx="281609" cy="30215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3DB6699-86DC-4994-8741-4272B38EA743}"/>
              </a:ext>
            </a:extLst>
          </p:cNvPr>
          <p:cNvSpPr txBox="1"/>
          <p:nvPr/>
        </p:nvSpPr>
        <p:spPr>
          <a:xfrm>
            <a:off x="328246" y="556550"/>
            <a:ext cx="62396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:  Box plot of </a:t>
            </a:r>
            <a:r>
              <a:rPr lang="en-US" sz="1200" i="1" dirty="0"/>
              <a:t>Pseudomona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undances 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A1B0A28-9B3F-4183-9471-59D425A8EC8C}"/>
              </a:ext>
            </a:extLst>
          </p:cNvPr>
          <p:cNvSpPr txBox="1"/>
          <p:nvPr/>
        </p:nvSpPr>
        <p:spPr>
          <a:xfrm>
            <a:off x="380620" y="5903587"/>
            <a:ext cx="790135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4:  Box plot of</a:t>
            </a:r>
            <a:r>
              <a:rPr lang="en-US" sz="1200" i="1" dirty="0"/>
              <a:t> Pseudomona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bundances in cilantro, cucumbers, masala spice mixes, smoked salmon, mung bean sprout A, and mung bean sprout B. Left panel shows a break out of 8 cilantro of sample groups, and mung bean sprout A and B. Right panel shows all samples of each food as one group. Circles represent garam masala sample with high abundances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seudomonas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6200000">
            <a:off x="-842068" y="2702353"/>
            <a:ext cx="208303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Proportional abundance</a:t>
            </a:r>
          </a:p>
        </p:txBody>
      </p:sp>
      <p:sp>
        <p:nvSpPr>
          <p:cNvPr id="11" name="TextBox 10"/>
          <p:cNvSpPr txBox="1"/>
          <p:nvPr/>
        </p:nvSpPr>
        <p:spPr>
          <a:xfrm rot="16200000">
            <a:off x="3692132" y="2614473"/>
            <a:ext cx="208303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Proportional abundance</a:t>
            </a:r>
          </a:p>
        </p:txBody>
      </p:sp>
    </p:spTree>
    <p:extLst>
      <p:ext uri="{BB962C8B-B14F-4D97-AF65-F5344CB8AC3E}">
        <p14:creationId xmlns:p14="http://schemas.microsoft.com/office/powerpoint/2010/main" val="22437307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730" y="1167466"/>
            <a:ext cx="4480560" cy="448056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35144" y="1167466"/>
            <a:ext cx="4480560" cy="4480560"/>
          </a:xfrm>
          <a:prstGeom prst="rect">
            <a:avLst/>
          </a:prstGeom>
        </p:spPr>
      </p:pic>
      <p:sp>
        <p:nvSpPr>
          <p:cNvPr id="4" name="Oval 3"/>
          <p:cNvSpPr/>
          <p:nvPr/>
        </p:nvSpPr>
        <p:spPr>
          <a:xfrm>
            <a:off x="2477495" y="1479555"/>
            <a:ext cx="281609" cy="30215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Oval 6"/>
          <p:cNvSpPr/>
          <p:nvPr/>
        </p:nvSpPr>
        <p:spPr>
          <a:xfrm>
            <a:off x="6216926" y="1495457"/>
            <a:ext cx="281609" cy="302150"/>
          </a:xfrm>
          <a:prstGeom prst="ellipse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EC4D24E-A4C7-47D5-BEA2-D25067886475}"/>
              </a:ext>
            </a:extLst>
          </p:cNvPr>
          <p:cNvSpPr txBox="1"/>
          <p:nvPr/>
        </p:nvSpPr>
        <p:spPr>
          <a:xfrm>
            <a:off x="328246" y="556550"/>
            <a:ext cx="62396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:  Box plot of </a:t>
            </a:r>
            <a:r>
              <a:rPr lang="en-US" sz="1200" i="1" dirty="0"/>
              <a:t>Pantoe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undances 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576C494-41AC-4425-9E3D-859B75ADEB80}"/>
              </a:ext>
            </a:extLst>
          </p:cNvPr>
          <p:cNvSpPr txBox="1"/>
          <p:nvPr/>
        </p:nvSpPr>
        <p:spPr>
          <a:xfrm>
            <a:off x="380620" y="5903587"/>
            <a:ext cx="790135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5:  Box plot of</a:t>
            </a:r>
            <a:r>
              <a:rPr lang="en-US" sz="1200" i="1" dirty="0"/>
              <a:t> Pantoe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bundances in cilantro, cucumbers, masala spice mixes, smoked salmon, mung bean sprout A, and mung bean sprout B. Left panel shows a break out of 8 cilantro sample groups, and mung bean sprout A and B. Right panel shows all samples of each food as one group. Circles represent garam masala samples with high proportional abundances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toea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-792633" y="2763218"/>
            <a:ext cx="208303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Proportional abundance</a:t>
            </a:r>
          </a:p>
        </p:txBody>
      </p:sp>
      <p:sp>
        <p:nvSpPr>
          <p:cNvPr id="13" name="TextBox 12"/>
          <p:cNvSpPr txBox="1"/>
          <p:nvPr/>
        </p:nvSpPr>
        <p:spPr>
          <a:xfrm rot="16200000">
            <a:off x="3558515" y="2846966"/>
            <a:ext cx="2083039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Proportional abundance</a:t>
            </a:r>
          </a:p>
        </p:txBody>
      </p:sp>
    </p:spTree>
    <p:extLst>
      <p:ext uri="{BB962C8B-B14F-4D97-AF65-F5344CB8AC3E}">
        <p14:creationId xmlns:p14="http://schemas.microsoft.com/office/powerpoint/2010/main" val="40055320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53</TotalTime>
  <Words>473</Words>
  <Application>Microsoft Office PowerPoint</Application>
  <PresentationFormat>On-screen Show (4:3)</PresentationFormat>
  <Paragraphs>2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FD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s</dc:title>
  <dc:creator>Jarvis, Karen</dc:creator>
  <cp:lastModifiedBy>Jarvis, Karen</cp:lastModifiedBy>
  <cp:revision>22</cp:revision>
  <cp:lastPrinted>2017-06-28T20:42:29Z</cp:lastPrinted>
  <dcterms:created xsi:type="dcterms:W3CDTF">2017-06-13T19:04:21Z</dcterms:created>
  <dcterms:modified xsi:type="dcterms:W3CDTF">2018-08-02T22:10:20Z</dcterms:modified>
</cp:coreProperties>
</file>